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C937CF-0F10-B8F1-847C-54AE6DB03B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189F763-9E3F-2586-4839-B39E6B55BE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3B9674-1173-F935-0E3F-D00E528AF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5A9BB6-D2A7-9690-A05F-78EECC4F5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D25464-0BE2-4CF1-CF16-07EAD83C5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567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382AFF-4EC7-268C-3DAC-01CF3B7B8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9217ED-B095-8EE0-878A-51AC368EB0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0A2D48-5B9A-CD68-AF4F-C6E67AA41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663379-ECBC-0FDE-A7DE-D07521C96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61EEB7-507C-8355-D994-2A60150F7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424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01CB54D-97B4-0C9A-2085-042C45DEEF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990E62-37F6-6D4A-F142-87CA216E7A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EF9BA1-8C07-3FB1-8A4E-A41E5BE5E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5C3B21-5F2C-B3F4-CEEB-AB033773C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397D38-41AE-E2B9-1727-3B3C66BB0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220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5A73DD-D12D-73E1-EF56-06DEE794C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39A3D67-5DC2-CFB3-E288-0130CE1B6E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E548D2-F01C-2F2A-0E18-B2C795323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29E895-1001-EEC6-F43D-0404BD772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45F820-BB99-FCA7-C90E-833454158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560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E0506A-FCB5-1339-2750-694C187A3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A6CA0C-2BD5-5BCC-AE9D-42FB83BCE5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D28886-6F71-4EF0-C297-9C368515D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800A6D-80AD-2026-29EB-625571354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DF565C-A36A-BAFC-6480-E2C0D9302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6471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346AE5-FDE8-C07A-C439-14E0999950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180460-D738-6D72-7C33-0CE318E2FE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7D90B9D-334B-31D0-A9BC-35C805547A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37517F-48C4-6B9F-1BD6-C067608BA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6B3AEF0-A1B5-D397-757B-01D1D817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CB129A-58DA-814B-8ECE-729234C05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040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BD380-EC83-B3D0-784A-45EA03EEE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91D7B1-455E-92A0-84A2-CA55BD770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2F9F500-EA81-077E-67D2-D1B744D180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2C50D4C-DE53-C6F7-710A-612DBB6576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6F225CC-A2FF-B662-415E-63A97E228D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3BA5C75-6BBE-CAB2-E435-CFDF93ECB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97691A1-1E6A-FA06-2154-703C34776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E812D58-714E-851D-7589-3CB5A7BC3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21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FA4F6E-1A40-8DEA-6390-C9C33B1B21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6CF2276-D2D8-3DB2-4345-973B56FAE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E08B385-A032-EBBD-6F8F-BCBEC31BA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9F6A9C5-B877-5C7D-83F3-EFA934352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5368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7916AF5-DEE4-F85B-760E-9A8372EAA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19F7058-79F3-C010-95F5-F3B22F5F8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0203136-534C-DEF8-350C-408235087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607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61A4A8-D0AC-2C50-45C4-C565FED38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DA031F3-7988-C46C-5420-57706E5B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AD29BD-B245-CF54-1D70-AC41DDD855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B459885-C39C-FF59-5FD3-1E6B69992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02B081-8276-F02E-FBC3-BDE804CEC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47A777-577A-623D-62A5-4C6B92CE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7277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CAD293-2883-9D3E-8601-A16A05EB2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8C62015-670A-5957-4D88-D0B6571666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451698-0785-63E6-84B8-9AC55E4EE3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F9DCBB-2EB3-6F26-0DC3-4B60FE39A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D19EA08-5637-A76C-A94F-93D1CDEA7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7DC04F-5C45-37E0-61E3-3CADD7C65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6023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18C8D2F-FCE5-A828-1B8B-5F31E13F59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BB770D-EDEC-866F-2A46-1456CAB336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2830CA-8376-4CC5-DF2E-B9B9AD52AD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03A66-80FB-49A5-A96F-DF147E3373AA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7BF2A2-6B08-7BEA-6FF8-9E2B525323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364E0C-8C46-30C1-844A-0EB97F32C6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55F-6541-4DAE-8342-5D83D41D0C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10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4ad4ab0acbf73c47bb3cb4be68f5f73">
            <a:extLst>
              <a:ext uri="{FF2B5EF4-FFF2-40B4-BE49-F238E27FC236}">
                <a16:creationId xmlns:a16="http://schemas.microsoft.com/office/drawing/2014/main" id="{AF14AB6C-0AF8-728B-2A81-A2FB46A430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086" b="9164"/>
          <a:stretch/>
        </p:blipFill>
        <p:spPr>
          <a:xfrm>
            <a:off x="1917066" y="531749"/>
            <a:ext cx="3864356" cy="2249551"/>
          </a:xfrm>
          <a:prstGeom prst="rect">
            <a:avLst/>
          </a:prstGeom>
        </p:spPr>
      </p:pic>
      <p:pic>
        <p:nvPicPr>
          <p:cNvPr id="4" name="图片 3" descr="e2c17a581864b9c2b24083812bf9dc7">
            <a:extLst>
              <a:ext uri="{FF2B5EF4-FFF2-40B4-BE49-F238E27FC236}">
                <a16:creationId xmlns:a16="http://schemas.microsoft.com/office/drawing/2014/main" id="{0EAADDE7-D4F7-E9CF-1A85-5185639A13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88" b="9071"/>
          <a:stretch/>
        </p:blipFill>
        <p:spPr>
          <a:xfrm>
            <a:off x="6050915" y="506349"/>
            <a:ext cx="4033901" cy="2274951"/>
          </a:xfrm>
          <a:prstGeom prst="rect">
            <a:avLst/>
          </a:prstGeom>
        </p:spPr>
      </p:pic>
      <p:pic>
        <p:nvPicPr>
          <p:cNvPr id="5" name="图片 4" descr="b459303e9fa78e121293b9e21d81e1e">
            <a:extLst>
              <a:ext uri="{FF2B5EF4-FFF2-40B4-BE49-F238E27FC236}">
                <a16:creationId xmlns:a16="http://schemas.microsoft.com/office/drawing/2014/main" id="{7ACC1EB0-3619-B29E-F21C-4F7392E13C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10" b="10167"/>
          <a:stretch/>
        </p:blipFill>
        <p:spPr>
          <a:xfrm>
            <a:off x="1840865" y="3126359"/>
            <a:ext cx="3957701" cy="2179066"/>
          </a:xfrm>
          <a:prstGeom prst="rect">
            <a:avLst/>
          </a:prstGeom>
        </p:spPr>
      </p:pic>
      <p:pic>
        <p:nvPicPr>
          <p:cNvPr id="6" name="图片 5" descr="2cddc7baa6308961c8ab57822ee848d">
            <a:extLst>
              <a:ext uri="{FF2B5EF4-FFF2-40B4-BE49-F238E27FC236}">
                <a16:creationId xmlns:a16="http://schemas.microsoft.com/office/drawing/2014/main" id="{E4A61062-18F5-E321-715A-6B0F1BD337F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994" b="7902"/>
          <a:stretch/>
        </p:blipFill>
        <p:spPr>
          <a:xfrm>
            <a:off x="6096000" y="3043809"/>
            <a:ext cx="3957701" cy="2274951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32B22E8-F396-9099-2884-A4E019B1B1F5}"/>
              </a:ext>
            </a:extLst>
          </p:cNvPr>
          <p:cNvSpPr txBox="1"/>
          <p:nvPr/>
        </p:nvSpPr>
        <p:spPr>
          <a:xfrm>
            <a:off x="3515969" y="372706"/>
            <a:ext cx="666550" cy="3827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spc="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Rg1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77EF144-DEB0-AB94-A3CD-BB62EC3A1163}"/>
              </a:ext>
            </a:extLst>
          </p:cNvPr>
          <p:cNvSpPr txBox="1"/>
          <p:nvPr/>
        </p:nvSpPr>
        <p:spPr>
          <a:xfrm>
            <a:off x="7746388" y="412937"/>
            <a:ext cx="6569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spc="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R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A9FC82-2A77-7065-721C-79532C9D8057}"/>
              </a:ext>
            </a:extLst>
          </p:cNvPr>
          <p:cNvSpPr txBox="1"/>
          <p:nvPr/>
        </p:nvSpPr>
        <p:spPr>
          <a:xfrm>
            <a:off x="3482281" y="2999443"/>
            <a:ext cx="733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spc="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PPT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14259B3-63FA-D1DE-607B-90CDABCFA562}"/>
              </a:ext>
            </a:extLst>
          </p:cNvPr>
          <p:cNvSpPr txBox="1"/>
          <p:nvPr/>
        </p:nvSpPr>
        <p:spPr>
          <a:xfrm>
            <a:off x="7746388" y="3000244"/>
            <a:ext cx="733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spc="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PP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C501763-8B66-871E-AEA3-05D9CDBD9F90}"/>
              </a:ext>
            </a:extLst>
          </p:cNvPr>
          <p:cNvSpPr txBox="1"/>
          <p:nvPr/>
        </p:nvSpPr>
        <p:spPr>
          <a:xfrm>
            <a:off x="3258609" y="5875946"/>
            <a:ext cx="609760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of ginsenoside content in hairy root of ginseng after ABA 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65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畅</dc:creator>
  <cp:lastModifiedBy>MDPI</cp:lastModifiedBy>
  <cp:revision>3</cp:revision>
  <dcterms:created xsi:type="dcterms:W3CDTF">2023-04-12T11:42:40Z</dcterms:created>
  <dcterms:modified xsi:type="dcterms:W3CDTF">2023-05-12T09:17:47Z</dcterms:modified>
</cp:coreProperties>
</file>